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030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1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45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8524517-64AD-4A44-8334-8C7AEF568B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734BD95-6EA3-4ED6-ABB8-8C6E2BFC4F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32D6FD3-75B4-4D1D-8951-3DFF433FE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9CD6108-1A62-4B02-A225-DDF033921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DFD264-63E5-462D-85B6-5E7FBD36E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7472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EEE8C7-1E54-4537-A5D4-1D6A2B325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648D6DC-CAAA-4427-8B3A-DAA664BFA2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B475078-9602-47D8-AAC7-36ED90B33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53458D4-FDC5-4242-B378-EA8B43F69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30663B-8538-424C-A479-CABCEE3BA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662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5847134-0374-4D51-877F-5048940250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FB6A27D-C5BD-4503-91C2-2755864461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F70E46D-871C-4A21-BB3F-6DBA3EBF9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D3AEE97-52EF-4D67-9F02-09B13DAA4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8E329-04A1-41B9-B4BD-270B5DEEE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7523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E77B50-09E7-4309-9401-1A00392369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DDB8CAB-C36D-4142-A237-3D425551E7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187EB8-BC7E-44A5-9C60-A84CE3531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BC97C17-F71F-49BE-BA8E-01B1713B42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B8FC000-9767-4853-BAE7-531B366B6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3680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9B00D51-FEF6-4563-AAEE-A180631B5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5ADF424-99BD-4623-A6A4-ECC574DCA9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A42B6BC-C1DE-4D95-90DB-6D5FB34F57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86B523F-6FFE-4F9C-97B0-20869A2D09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780BC45-00B6-4EFB-94B3-8F9F2D1E5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3675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E6C5F65-A81E-4018-8B6B-424225C58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461E57D-F5E8-4892-9476-3A15AA19D8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AE6AC59-0D5C-44AD-B6B6-9DF3291605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CF32CBB-60DA-491B-A45E-F0805BC1C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371D0DD-E7A1-4343-9AFA-E737A75A0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9D8CD9C-94FB-4CE4-8F7C-DEBF15416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4102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1688FBF-3A38-428B-947F-B88C6783A3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0808FB8-109C-4588-B974-B6DF79FC1D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06980C7-CED9-4548-B23E-9CFFA0AC95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88D001F-8D84-4A3B-9473-878E51CDB2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4F56CB9-136C-453C-B94F-7A05C82A52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9F0B024-3646-43F5-8F17-2E81CD6AE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8DCC9BF-A0CF-49A0-8889-0CB8B3C3E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525DA50-044D-4731-A7E0-0A9D2A97A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9788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CEEB57-5753-4EF2-B0C1-A1FBA8A808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E3BF811-7815-4993-9F03-795B82774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DD74645-8198-4F3F-B23E-995DAF64B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C877A66-0F1A-49DB-B045-8758225A7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9565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EED9EAB7-9743-40D0-85D0-3E3362F78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222FFE8-4E73-4923-864D-B87EE0F73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3B4C9AE-1651-44F5-A512-F275DAA1C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8501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2760140-3EFD-4863-8061-4C9916C5D3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8E2BD8-B6ED-48BA-998B-E95AD05F35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9493240-8265-4F6A-BC1C-AFF8F91D2F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8E4C59C-F7D6-4E0D-B134-3CC25F929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EE236B2-5176-4660-8484-C4D523DB1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9EA2A9-950B-45A2-9AD5-1E3074565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5219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C5E7B7A-4D62-4967-9BC0-277DFE936A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7DD6246-1E7C-4A25-9E59-59392ACF35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1439E1F-0C58-4972-8DCB-BCA44B8C61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8B5353F-6CBE-478B-B7C8-5CADD8634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22F9454-4626-4E7D-9C28-66BEDFDE1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7F14AEC-F613-4AD5-820C-62D6C663A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5808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1B4DF81-44CF-45A9-B442-51AB4EA3AF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E74A893-B1EF-46C8-BAFB-AEC280BE35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01D97A7-DC98-4E9D-B929-484931511A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ACCCE-34F1-4EB6-BEBD-9AEF75C53FFF}" type="datetimeFigureOut">
              <a:rPr lang="fr-FR" smtClean="0"/>
              <a:t>24/12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7881078-1F9E-46F1-A5AF-1C64CD9CE9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C548101-1001-46F9-A3BB-870C270966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3A5CB-A3EA-4486-9886-57667B4B773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6372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CED5B0F0-4CCA-412A-9169-2BA540990F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6002" y="0"/>
            <a:ext cx="6858000" cy="68580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B7B6D6AD-A3B3-4EF7-A700-B8507269FCB1}"/>
              </a:ext>
            </a:extLst>
          </p:cNvPr>
          <p:cNvSpPr/>
          <p:nvPr/>
        </p:nvSpPr>
        <p:spPr>
          <a:xfrm>
            <a:off x="4465936" y="245375"/>
            <a:ext cx="3260128" cy="227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i="1" dirty="0" err="1">
                <a:solidFill>
                  <a:schemeClr val="tx1"/>
                </a:solidFill>
              </a:rPr>
              <a:t>rhs</a:t>
            </a:r>
            <a:r>
              <a:rPr lang="fr-FR" dirty="0">
                <a:solidFill>
                  <a:schemeClr val="tx1"/>
                </a:solidFill>
              </a:rPr>
              <a:t> </a:t>
            </a:r>
            <a:r>
              <a:rPr lang="fr-FR" dirty="0" err="1">
                <a:solidFill>
                  <a:schemeClr val="tx1"/>
                </a:solidFill>
              </a:rPr>
              <a:t>nucleotide</a:t>
            </a:r>
            <a:r>
              <a:rPr lang="fr-FR" dirty="0">
                <a:solidFill>
                  <a:schemeClr val="tx1"/>
                </a:solidFill>
              </a:rPr>
              <a:t> distanc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11D02DD-1765-494A-82BE-AB3F7296F181}"/>
              </a:ext>
            </a:extLst>
          </p:cNvPr>
          <p:cNvSpPr/>
          <p:nvPr/>
        </p:nvSpPr>
        <p:spPr>
          <a:xfrm>
            <a:off x="9537198" y="2418743"/>
            <a:ext cx="168751" cy="20205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" rtlCol="0" anchor="ctr"/>
          <a:lstStyle/>
          <a:p>
            <a:pPr algn="ctr"/>
            <a:r>
              <a:rPr lang="fr-FR" sz="1400" dirty="0" err="1">
                <a:solidFill>
                  <a:schemeClr val="tx1"/>
                </a:solidFill>
              </a:rPr>
              <a:t>Nucleotide</a:t>
            </a:r>
            <a:r>
              <a:rPr lang="fr-FR" sz="1400" dirty="0">
                <a:solidFill>
                  <a:schemeClr val="tx1"/>
                </a:solidFill>
              </a:rPr>
              <a:t> distanc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5F8A357-E997-4907-A55D-F094D4819625}"/>
              </a:ext>
            </a:extLst>
          </p:cNvPr>
          <p:cNvSpPr/>
          <p:nvPr/>
        </p:nvSpPr>
        <p:spPr>
          <a:xfrm>
            <a:off x="3135583" y="502618"/>
            <a:ext cx="3875603" cy="386349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" name="Connecteur droit avec flèche 5">
            <a:extLst>
              <a:ext uri="{FF2B5EF4-FFF2-40B4-BE49-F238E27FC236}">
                <a16:creationId xmlns:a16="http://schemas.microsoft.com/office/drawing/2014/main" id="{9424D446-0587-4F44-9016-449A58B4FCC9}"/>
              </a:ext>
            </a:extLst>
          </p:cNvPr>
          <p:cNvCxnSpPr>
            <a:cxnSpLocks/>
          </p:cNvCxnSpPr>
          <p:nvPr/>
        </p:nvCxnSpPr>
        <p:spPr>
          <a:xfrm flipV="1">
            <a:off x="2485143" y="2682644"/>
            <a:ext cx="633506" cy="1365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ZoneTexte 6">
            <a:extLst>
              <a:ext uri="{FF2B5EF4-FFF2-40B4-BE49-F238E27FC236}">
                <a16:creationId xmlns:a16="http://schemas.microsoft.com/office/drawing/2014/main" id="{9FC354A5-A5A2-41C7-8845-64B17968596E}"/>
              </a:ext>
            </a:extLst>
          </p:cNvPr>
          <p:cNvSpPr txBox="1"/>
          <p:nvPr/>
        </p:nvSpPr>
        <p:spPr>
          <a:xfrm>
            <a:off x="1179285" y="2612294"/>
            <a:ext cx="1225704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rhs</a:t>
            </a:r>
            <a:r>
              <a:rPr lang="fr-FR" sz="1600" b="1" dirty="0"/>
              <a:t>_M1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r>
              <a:rPr lang="fr-FR" sz="1400" dirty="0"/>
              <a:t>  Max-Min</a:t>
            </a:r>
          </a:p>
          <a:p>
            <a:pPr algn="ctr"/>
            <a:r>
              <a:rPr lang="fr-FR" sz="1400" dirty="0"/>
              <a:t>[100-71%]</a:t>
            </a:r>
          </a:p>
        </p:txBody>
      </p:sp>
      <p:cxnSp>
        <p:nvCxnSpPr>
          <p:cNvPr id="8" name="Connecteur droit avec flèche 7">
            <a:extLst>
              <a:ext uri="{FF2B5EF4-FFF2-40B4-BE49-F238E27FC236}">
                <a16:creationId xmlns:a16="http://schemas.microsoft.com/office/drawing/2014/main" id="{E2302289-59D6-4E28-BCB1-1E9EAA9E3AA5}"/>
              </a:ext>
            </a:extLst>
          </p:cNvPr>
          <p:cNvCxnSpPr>
            <a:cxnSpLocks/>
          </p:cNvCxnSpPr>
          <p:nvPr/>
        </p:nvCxnSpPr>
        <p:spPr>
          <a:xfrm flipH="1">
            <a:off x="8131036" y="5020117"/>
            <a:ext cx="1364190" cy="3443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ZoneTexte 8">
            <a:extLst>
              <a:ext uri="{FF2B5EF4-FFF2-40B4-BE49-F238E27FC236}">
                <a16:creationId xmlns:a16="http://schemas.microsoft.com/office/drawing/2014/main" id="{37F99C4C-A545-447B-802B-05BB5BDE35EC}"/>
              </a:ext>
            </a:extLst>
          </p:cNvPr>
          <p:cNvSpPr txBox="1"/>
          <p:nvPr/>
        </p:nvSpPr>
        <p:spPr>
          <a:xfrm>
            <a:off x="9549626" y="4543063"/>
            <a:ext cx="117739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/>
              <a:t>rhs</a:t>
            </a:r>
            <a:r>
              <a:rPr lang="fr-FR" sz="1600" b="1" dirty="0"/>
              <a:t>_M2</a:t>
            </a:r>
          </a:p>
          <a:p>
            <a:pPr algn="ctr"/>
            <a:r>
              <a:rPr lang="fr-FR" sz="1400" dirty="0"/>
              <a:t>% of </a:t>
            </a:r>
            <a:r>
              <a:rPr lang="fr-FR" sz="1400" dirty="0" err="1"/>
              <a:t>identity</a:t>
            </a:r>
            <a:endParaRPr lang="fr-FR" sz="1400" dirty="0"/>
          </a:p>
          <a:p>
            <a:pPr algn="ctr"/>
            <a:r>
              <a:rPr lang="fr-FR" sz="1400" dirty="0"/>
              <a:t>Max-Min</a:t>
            </a:r>
          </a:p>
          <a:p>
            <a:pPr algn="ctr"/>
            <a:r>
              <a:rPr lang="fr-FR" sz="1200" dirty="0"/>
              <a:t>[100-88%]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8158D55-6123-459B-8D83-C3AA9A814511}"/>
              </a:ext>
            </a:extLst>
          </p:cNvPr>
          <p:cNvSpPr/>
          <p:nvPr/>
        </p:nvSpPr>
        <p:spPr>
          <a:xfrm>
            <a:off x="6994253" y="4366111"/>
            <a:ext cx="1136784" cy="113106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2" name="Groupe 11">
            <a:extLst>
              <a:ext uri="{FF2B5EF4-FFF2-40B4-BE49-F238E27FC236}">
                <a16:creationId xmlns:a16="http://schemas.microsoft.com/office/drawing/2014/main" id="{CD561FED-3B2D-4F94-A155-4D873D72917B}"/>
              </a:ext>
            </a:extLst>
          </p:cNvPr>
          <p:cNvGrpSpPr/>
          <p:nvPr/>
        </p:nvGrpSpPr>
        <p:grpSpPr>
          <a:xfrm>
            <a:off x="9467230" y="116475"/>
            <a:ext cx="2973294" cy="941438"/>
            <a:chOff x="9344212" y="273739"/>
            <a:chExt cx="2973294" cy="941438"/>
          </a:xfrm>
        </p:grpSpPr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7882EAC4-10E1-4885-91D6-09676DCC3E0C}"/>
                </a:ext>
              </a:extLst>
            </p:cNvPr>
            <p:cNvSpPr txBox="1"/>
            <p:nvPr/>
          </p:nvSpPr>
          <p:spPr>
            <a:xfrm>
              <a:off x="9705788" y="273739"/>
              <a:ext cx="23509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morganii</a:t>
              </a:r>
              <a:r>
                <a:rPr lang="en-US" sz="14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subsp. </a:t>
              </a:r>
              <a:r>
                <a:rPr lang="en-US" sz="1400" i="1" dirty="0">
                  <a:solidFill>
                    <a:srgbClr val="1F1F1F"/>
                  </a:solidFill>
                  <a:ea typeface="Times New Roman" panose="02020603050405020304" pitchFamily="18" charset="0"/>
                </a:rPr>
                <a:t>morganii</a:t>
              </a:r>
              <a:endParaRPr lang="fr-FR" sz="1400" dirty="0"/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BC6CA266-FBF1-431A-BE1C-B7F30738162C}"/>
                </a:ext>
              </a:extLst>
            </p:cNvPr>
            <p:cNvSpPr txBox="1"/>
            <p:nvPr/>
          </p:nvSpPr>
          <p:spPr>
            <a:xfrm>
              <a:off x="9705788" y="609776"/>
              <a:ext cx="26117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morganii</a:t>
              </a:r>
              <a:r>
                <a:rPr lang="en-US" sz="1400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 subsp. </a:t>
              </a:r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intermedius</a:t>
              </a:r>
              <a:endParaRPr lang="fr-FR" sz="1400" i="1" dirty="0"/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C47FC5E9-3D08-4672-AA42-7F94CA9CD124}"/>
                </a:ext>
              </a:extLst>
            </p:cNvPr>
            <p:cNvSpPr txBox="1"/>
            <p:nvPr/>
          </p:nvSpPr>
          <p:spPr>
            <a:xfrm>
              <a:off x="9705788" y="907400"/>
              <a:ext cx="26117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i="1" dirty="0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M. </a:t>
              </a:r>
              <a:r>
                <a:rPr lang="en-US" sz="1400" i="1" dirty="0" err="1">
                  <a:solidFill>
                    <a:srgbClr val="000000"/>
                  </a:solidFill>
                  <a:effectLst/>
                  <a:ea typeface="Times New Roman" panose="02020603050405020304" pitchFamily="18" charset="0"/>
                </a:rPr>
                <a:t>sibonii</a:t>
              </a:r>
              <a:endParaRPr lang="fr-FR" sz="1400" dirty="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3300ABBD-77D2-4857-B851-0EC94E09BC89}"/>
                </a:ext>
              </a:extLst>
            </p:cNvPr>
            <p:cNvSpPr/>
            <p:nvPr/>
          </p:nvSpPr>
          <p:spPr>
            <a:xfrm>
              <a:off x="9357375" y="962486"/>
              <a:ext cx="348413" cy="234709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9CEF65D3-BDBD-4397-906F-4D600D89E616}"/>
                </a:ext>
              </a:extLst>
            </p:cNvPr>
            <p:cNvSpPr/>
            <p:nvPr/>
          </p:nvSpPr>
          <p:spPr>
            <a:xfrm>
              <a:off x="9357375" y="625609"/>
              <a:ext cx="348413" cy="234709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5E8515C8-2149-4808-9BC1-A3D292FC0362}"/>
                </a:ext>
              </a:extLst>
            </p:cNvPr>
            <p:cNvSpPr/>
            <p:nvPr/>
          </p:nvSpPr>
          <p:spPr>
            <a:xfrm>
              <a:off x="9344212" y="310272"/>
              <a:ext cx="348413" cy="234709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46" name="Groupe 45">
            <a:extLst>
              <a:ext uri="{FF2B5EF4-FFF2-40B4-BE49-F238E27FC236}">
                <a16:creationId xmlns:a16="http://schemas.microsoft.com/office/drawing/2014/main" id="{970FA7C7-9E12-43D4-8B9C-C9E488341C70}"/>
              </a:ext>
            </a:extLst>
          </p:cNvPr>
          <p:cNvGrpSpPr/>
          <p:nvPr/>
        </p:nvGrpSpPr>
        <p:grpSpPr>
          <a:xfrm>
            <a:off x="3138819" y="6259491"/>
            <a:ext cx="5758406" cy="276593"/>
            <a:chOff x="3138819" y="6259491"/>
            <a:chExt cx="5758406" cy="276593"/>
          </a:xfrm>
        </p:grpSpPr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19BE57CF-E252-4671-88F7-941A7F37D3F2}"/>
                </a:ext>
              </a:extLst>
            </p:cNvPr>
            <p:cNvSpPr/>
            <p:nvPr/>
          </p:nvSpPr>
          <p:spPr>
            <a:xfrm>
              <a:off x="3138819" y="6260352"/>
              <a:ext cx="391034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48B90BB3-DE7D-48F3-A32C-C2E676F07CE4}"/>
                </a:ext>
              </a:extLst>
            </p:cNvPr>
            <p:cNvSpPr/>
            <p:nvPr/>
          </p:nvSpPr>
          <p:spPr>
            <a:xfrm>
              <a:off x="3529853" y="6260352"/>
              <a:ext cx="181535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B42EBF27-7327-4543-A1B2-47A3E30AE9DE}"/>
                </a:ext>
              </a:extLst>
            </p:cNvPr>
            <p:cNvSpPr/>
            <p:nvPr/>
          </p:nvSpPr>
          <p:spPr>
            <a:xfrm>
              <a:off x="3709325" y="6260352"/>
              <a:ext cx="118111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367BA9A8-7A6A-4A57-9A08-DE3E7235F81E}"/>
                </a:ext>
              </a:extLst>
            </p:cNvPr>
            <p:cNvSpPr/>
            <p:nvPr/>
          </p:nvSpPr>
          <p:spPr>
            <a:xfrm>
              <a:off x="3822517" y="6260352"/>
              <a:ext cx="1152895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8791223D-5C5A-4F8C-8638-FF3808808438}"/>
                </a:ext>
              </a:extLst>
            </p:cNvPr>
            <p:cNvSpPr/>
            <p:nvPr/>
          </p:nvSpPr>
          <p:spPr>
            <a:xfrm>
              <a:off x="6812259" y="6260352"/>
              <a:ext cx="187497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61CEF430-8892-4CD7-A543-291CE3F73026}"/>
                </a:ext>
              </a:extLst>
            </p:cNvPr>
            <p:cNvSpPr/>
            <p:nvPr/>
          </p:nvSpPr>
          <p:spPr>
            <a:xfrm>
              <a:off x="6740312" y="6260352"/>
              <a:ext cx="73016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64D1DCB2-441B-47B2-BF2B-0546F65AFF78}"/>
                </a:ext>
              </a:extLst>
            </p:cNvPr>
            <p:cNvSpPr/>
            <p:nvPr/>
          </p:nvSpPr>
          <p:spPr>
            <a:xfrm>
              <a:off x="6675089" y="6260352"/>
              <a:ext cx="65402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0FAC4EEB-6540-4B6C-89BC-3C67FB420388}"/>
                </a:ext>
              </a:extLst>
            </p:cNvPr>
            <p:cNvSpPr/>
            <p:nvPr/>
          </p:nvSpPr>
          <p:spPr>
            <a:xfrm>
              <a:off x="5527571" y="6260352"/>
              <a:ext cx="1155110" cy="275732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B0E9E51F-D1E6-4DA8-882F-5C87013B5CAB}"/>
                </a:ext>
              </a:extLst>
            </p:cNvPr>
            <p:cNvSpPr/>
            <p:nvPr/>
          </p:nvSpPr>
          <p:spPr>
            <a:xfrm>
              <a:off x="4972984" y="6260352"/>
              <a:ext cx="240242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4FB57E1F-72BB-4B7E-BA6E-B39A1A537D73}"/>
                </a:ext>
              </a:extLst>
            </p:cNvPr>
            <p:cNvSpPr/>
            <p:nvPr/>
          </p:nvSpPr>
          <p:spPr>
            <a:xfrm>
              <a:off x="5211387" y="6260352"/>
              <a:ext cx="133297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00F66D31-0FC8-493A-A9D5-2D83A52B5FEB}"/>
                </a:ext>
              </a:extLst>
            </p:cNvPr>
            <p:cNvSpPr/>
            <p:nvPr/>
          </p:nvSpPr>
          <p:spPr>
            <a:xfrm>
              <a:off x="5341446" y="6260352"/>
              <a:ext cx="134109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3292E6E4-EDCD-428B-9283-29690992DFDE}"/>
                </a:ext>
              </a:extLst>
            </p:cNvPr>
            <p:cNvSpPr/>
            <p:nvPr/>
          </p:nvSpPr>
          <p:spPr>
            <a:xfrm>
              <a:off x="5468893" y="6260352"/>
              <a:ext cx="65402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FE416359-6FA1-413B-9E7F-4D05BEB7A285}"/>
                </a:ext>
              </a:extLst>
            </p:cNvPr>
            <p:cNvSpPr/>
            <p:nvPr/>
          </p:nvSpPr>
          <p:spPr>
            <a:xfrm>
              <a:off x="7255918" y="6260352"/>
              <a:ext cx="195505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20998D99-0DA6-410A-8E75-1D880F02A459}"/>
                </a:ext>
              </a:extLst>
            </p:cNvPr>
            <p:cNvSpPr/>
            <p:nvPr/>
          </p:nvSpPr>
          <p:spPr>
            <a:xfrm>
              <a:off x="7450722" y="6260352"/>
              <a:ext cx="65402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48ADE665-EDA3-48D6-A54C-33A12F97FE0F}"/>
                </a:ext>
              </a:extLst>
            </p:cNvPr>
            <p:cNvSpPr/>
            <p:nvPr/>
          </p:nvSpPr>
          <p:spPr>
            <a:xfrm>
              <a:off x="7511711" y="6260352"/>
              <a:ext cx="67039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0120AC18-BC98-49D5-8B76-82601581B654}"/>
                </a:ext>
              </a:extLst>
            </p:cNvPr>
            <p:cNvSpPr/>
            <p:nvPr/>
          </p:nvSpPr>
          <p:spPr>
            <a:xfrm>
              <a:off x="7576413" y="6260352"/>
              <a:ext cx="240643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38114FE1-6C43-4D19-B28A-D562E4EB0479}"/>
                </a:ext>
              </a:extLst>
            </p:cNvPr>
            <p:cNvSpPr/>
            <p:nvPr/>
          </p:nvSpPr>
          <p:spPr>
            <a:xfrm>
              <a:off x="7816832" y="6260352"/>
              <a:ext cx="209681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3788FFCB-3D10-4334-927B-14558894B9C0}"/>
                </a:ext>
              </a:extLst>
            </p:cNvPr>
            <p:cNvSpPr/>
            <p:nvPr/>
          </p:nvSpPr>
          <p:spPr>
            <a:xfrm>
              <a:off x="8023952" y="6260352"/>
              <a:ext cx="124966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1D97EA82-BE8D-43DE-A84D-D8C4BDA1FC03}"/>
                </a:ext>
              </a:extLst>
            </p:cNvPr>
            <p:cNvSpPr/>
            <p:nvPr/>
          </p:nvSpPr>
          <p:spPr>
            <a:xfrm>
              <a:off x="7060045" y="6260352"/>
              <a:ext cx="195873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DE0AD8CF-5AE3-4F62-A816-70E6FDD70AF0}"/>
                </a:ext>
              </a:extLst>
            </p:cNvPr>
            <p:cNvSpPr/>
            <p:nvPr/>
          </p:nvSpPr>
          <p:spPr>
            <a:xfrm>
              <a:off x="6992800" y="6260352"/>
              <a:ext cx="73016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2708CEB7-75F9-4853-A3E5-FA33829733DE}"/>
                </a:ext>
              </a:extLst>
            </p:cNvPr>
            <p:cNvSpPr/>
            <p:nvPr/>
          </p:nvSpPr>
          <p:spPr>
            <a:xfrm>
              <a:off x="8148918" y="6260352"/>
              <a:ext cx="63968" cy="272336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7CCAB098-E2DE-4A59-A90A-ED46F1737E21}"/>
                </a:ext>
              </a:extLst>
            </p:cNvPr>
            <p:cNvSpPr/>
            <p:nvPr/>
          </p:nvSpPr>
          <p:spPr>
            <a:xfrm>
              <a:off x="8212886" y="6260352"/>
              <a:ext cx="124966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B82D48A4-E0B8-47A6-B6F7-4C668E56B410}"/>
                </a:ext>
              </a:extLst>
            </p:cNvPr>
            <p:cNvSpPr/>
            <p:nvPr/>
          </p:nvSpPr>
          <p:spPr>
            <a:xfrm>
              <a:off x="8335291" y="6260352"/>
              <a:ext cx="124966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63D70729-97E9-4D1D-8808-3DA605389325}"/>
                </a:ext>
              </a:extLst>
            </p:cNvPr>
            <p:cNvSpPr/>
            <p:nvPr/>
          </p:nvSpPr>
          <p:spPr>
            <a:xfrm>
              <a:off x="8457474" y="6260352"/>
              <a:ext cx="63968" cy="272336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A79618C1-1192-41D0-B8DC-1AFACCAAB641}"/>
                </a:ext>
              </a:extLst>
            </p:cNvPr>
            <p:cNvSpPr/>
            <p:nvPr/>
          </p:nvSpPr>
          <p:spPr>
            <a:xfrm>
              <a:off x="8520179" y="6260352"/>
              <a:ext cx="124966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2B46836F-F24A-49D7-9B9B-894AD9DFEF59}"/>
                </a:ext>
              </a:extLst>
            </p:cNvPr>
            <p:cNvSpPr/>
            <p:nvPr/>
          </p:nvSpPr>
          <p:spPr>
            <a:xfrm>
              <a:off x="8642363" y="6260352"/>
              <a:ext cx="188907" cy="272336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DB2DDA11-0AD5-4C9F-B898-297CCD47F2F1}"/>
                </a:ext>
              </a:extLst>
            </p:cNvPr>
            <p:cNvSpPr/>
            <p:nvPr/>
          </p:nvSpPr>
          <p:spPr>
            <a:xfrm>
              <a:off x="8830186" y="6259491"/>
              <a:ext cx="67039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47" name="Groupe 46">
            <a:extLst>
              <a:ext uri="{FF2B5EF4-FFF2-40B4-BE49-F238E27FC236}">
                <a16:creationId xmlns:a16="http://schemas.microsoft.com/office/drawing/2014/main" id="{FD6C9A73-DFD9-465F-8EC8-FC35C380A11D}"/>
              </a:ext>
            </a:extLst>
          </p:cNvPr>
          <p:cNvGrpSpPr/>
          <p:nvPr/>
        </p:nvGrpSpPr>
        <p:grpSpPr>
          <a:xfrm rot="5400000">
            <a:off x="116316" y="3243171"/>
            <a:ext cx="5758406" cy="277299"/>
            <a:chOff x="3138819" y="6257440"/>
            <a:chExt cx="5758406" cy="277299"/>
          </a:xfrm>
        </p:grpSpPr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C2553F80-C7AE-494A-8806-CD71C72AF6AD}"/>
                </a:ext>
              </a:extLst>
            </p:cNvPr>
            <p:cNvSpPr/>
            <p:nvPr/>
          </p:nvSpPr>
          <p:spPr>
            <a:xfrm>
              <a:off x="3138819" y="6260352"/>
              <a:ext cx="391034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6A67C959-5FA5-4AB7-B8F4-72714396C8B9}"/>
                </a:ext>
              </a:extLst>
            </p:cNvPr>
            <p:cNvSpPr/>
            <p:nvPr/>
          </p:nvSpPr>
          <p:spPr>
            <a:xfrm>
              <a:off x="3529853" y="6260352"/>
              <a:ext cx="181535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1EFB7578-904D-41D9-A8CD-D44473A8D9FE}"/>
                </a:ext>
              </a:extLst>
            </p:cNvPr>
            <p:cNvSpPr/>
            <p:nvPr/>
          </p:nvSpPr>
          <p:spPr>
            <a:xfrm>
              <a:off x="3709695" y="6260352"/>
              <a:ext cx="114829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EC9F3E14-558A-4D48-9E5F-871232313DCD}"/>
                </a:ext>
              </a:extLst>
            </p:cNvPr>
            <p:cNvSpPr/>
            <p:nvPr/>
          </p:nvSpPr>
          <p:spPr>
            <a:xfrm>
              <a:off x="3822517" y="6260352"/>
              <a:ext cx="1152895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64723569-7816-42D4-94C9-5352F7627E4E}"/>
                </a:ext>
              </a:extLst>
            </p:cNvPr>
            <p:cNvSpPr/>
            <p:nvPr/>
          </p:nvSpPr>
          <p:spPr>
            <a:xfrm>
              <a:off x="6812259" y="6260352"/>
              <a:ext cx="187497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C6BAF101-2AF6-4D13-AFC5-DE12EFF12E57}"/>
                </a:ext>
              </a:extLst>
            </p:cNvPr>
            <p:cNvSpPr/>
            <p:nvPr/>
          </p:nvSpPr>
          <p:spPr>
            <a:xfrm>
              <a:off x="6740312" y="6260352"/>
              <a:ext cx="73016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5AD55C07-56BE-4006-8315-8844432A575D}"/>
                </a:ext>
              </a:extLst>
            </p:cNvPr>
            <p:cNvSpPr/>
            <p:nvPr/>
          </p:nvSpPr>
          <p:spPr>
            <a:xfrm>
              <a:off x="6675089" y="6260352"/>
              <a:ext cx="65402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29B88D57-0085-4E88-8991-1210E34DB333}"/>
                </a:ext>
              </a:extLst>
            </p:cNvPr>
            <p:cNvSpPr/>
            <p:nvPr/>
          </p:nvSpPr>
          <p:spPr>
            <a:xfrm>
              <a:off x="5527571" y="6257440"/>
              <a:ext cx="1155110" cy="275732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789D47F6-9755-4D37-AC37-27867ACA4628}"/>
                </a:ext>
              </a:extLst>
            </p:cNvPr>
            <p:cNvSpPr/>
            <p:nvPr/>
          </p:nvSpPr>
          <p:spPr>
            <a:xfrm>
              <a:off x="4974306" y="6260352"/>
              <a:ext cx="240242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557ED8AA-289A-485D-9E6F-D2AA750C82A7}"/>
                </a:ext>
              </a:extLst>
            </p:cNvPr>
            <p:cNvSpPr/>
            <p:nvPr/>
          </p:nvSpPr>
          <p:spPr>
            <a:xfrm>
              <a:off x="5214552" y="6260352"/>
              <a:ext cx="138600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D4460C2F-04AA-433D-B45E-38FC23A4D9B1}"/>
                </a:ext>
              </a:extLst>
            </p:cNvPr>
            <p:cNvSpPr/>
            <p:nvPr/>
          </p:nvSpPr>
          <p:spPr>
            <a:xfrm>
              <a:off x="5349431" y="6260352"/>
              <a:ext cx="126124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EC83BBB1-431F-47BF-8FE2-6998D7BE4A80}"/>
                </a:ext>
              </a:extLst>
            </p:cNvPr>
            <p:cNvSpPr/>
            <p:nvPr/>
          </p:nvSpPr>
          <p:spPr>
            <a:xfrm>
              <a:off x="5468893" y="6260352"/>
              <a:ext cx="65402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888CE5E8-6BA5-494D-A022-F745A6622757}"/>
                </a:ext>
              </a:extLst>
            </p:cNvPr>
            <p:cNvSpPr/>
            <p:nvPr/>
          </p:nvSpPr>
          <p:spPr>
            <a:xfrm>
              <a:off x="7255918" y="6260352"/>
              <a:ext cx="195505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CC48F3AC-DE96-4695-AF95-D0BBA4379B1B}"/>
                </a:ext>
              </a:extLst>
            </p:cNvPr>
            <p:cNvSpPr/>
            <p:nvPr/>
          </p:nvSpPr>
          <p:spPr>
            <a:xfrm>
              <a:off x="7450722" y="6260352"/>
              <a:ext cx="65402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986B811D-19D2-4653-A9F4-0A48751D1AD4}"/>
                </a:ext>
              </a:extLst>
            </p:cNvPr>
            <p:cNvSpPr/>
            <p:nvPr/>
          </p:nvSpPr>
          <p:spPr>
            <a:xfrm>
              <a:off x="7511711" y="6260352"/>
              <a:ext cx="67039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059BB73D-845A-4CDF-8620-1A19A753453B}"/>
                </a:ext>
              </a:extLst>
            </p:cNvPr>
            <p:cNvSpPr/>
            <p:nvPr/>
          </p:nvSpPr>
          <p:spPr>
            <a:xfrm>
              <a:off x="7576413" y="6260352"/>
              <a:ext cx="240643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56884E1F-560C-4D48-8280-D12B890F2607}"/>
                </a:ext>
              </a:extLst>
            </p:cNvPr>
            <p:cNvSpPr/>
            <p:nvPr/>
          </p:nvSpPr>
          <p:spPr>
            <a:xfrm>
              <a:off x="7816832" y="6260352"/>
              <a:ext cx="209681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0589AC28-655A-4D73-8870-10CE59A4A33B}"/>
                </a:ext>
              </a:extLst>
            </p:cNvPr>
            <p:cNvSpPr/>
            <p:nvPr/>
          </p:nvSpPr>
          <p:spPr>
            <a:xfrm>
              <a:off x="8023952" y="6260352"/>
              <a:ext cx="124966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C55D639A-0409-45F4-BDA5-9CA7A2C17B79}"/>
                </a:ext>
              </a:extLst>
            </p:cNvPr>
            <p:cNvSpPr/>
            <p:nvPr/>
          </p:nvSpPr>
          <p:spPr>
            <a:xfrm>
              <a:off x="7060045" y="6260352"/>
              <a:ext cx="195873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AC53D8D3-EAEE-401F-B848-89EB26D906F1}"/>
                </a:ext>
              </a:extLst>
            </p:cNvPr>
            <p:cNvSpPr/>
            <p:nvPr/>
          </p:nvSpPr>
          <p:spPr>
            <a:xfrm>
              <a:off x="6992800" y="6260352"/>
              <a:ext cx="73016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C5060104-8021-4CFC-AF3B-5E5F31961CDC}"/>
                </a:ext>
              </a:extLst>
            </p:cNvPr>
            <p:cNvSpPr/>
            <p:nvPr/>
          </p:nvSpPr>
          <p:spPr>
            <a:xfrm>
              <a:off x="8148918" y="6260352"/>
              <a:ext cx="63968" cy="272336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F73A2AA4-BCBD-45B4-BE00-5C76868C7038}"/>
                </a:ext>
              </a:extLst>
            </p:cNvPr>
            <p:cNvSpPr/>
            <p:nvPr/>
          </p:nvSpPr>
          <p:spPr>
            <a:xfrm>
              <a:off x="8212886" y="6260352"/>
              <a:ext cx="124966" cy="272336"/>
            </a:xfrm>
            <a:prstGeom prst="rect">
              <a:avLst/>
            </a:prstGeom>
            <a:solidFill>
              <a:srgbClr val="FF0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AF55EA2A-7F14-4F4E-9C24-DFDDD0E9FCED}"/>
                </a:ext>
              </a:extLst>
            </p:cNvPr>
            <p:cNvSpPr/>
            <p:nvPr/>
          </p:nvSpPr>
          <p:spPr>
            <a:xfrm>
              <a:off x="8335291" y="6260352"/>
              <a:ext cx="124966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F7B1C944-2567-4D48-84B3-11742201FEE7}"/>
                </a:ext>
              </a:extLst>
            </p:cNvPr>
            <p:cNvSpPr/>
            <p:nvPr/>
          </p:nvSpPr>
          <p:spPr>
            <a:xfrm>
              <a:off x="8461707" y="6260352"/>
              <a:ext cx="63968" cy="272336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8F669CD0-32E8-4D82-825B-8AF261986ACA}"/>
                </a:ext>
              </a:extLst>
            </p:cNvPr>
            <p:cNvSpPr/>
            <p:nvPr/>
          </p:nvSpPr>
          <p:spPr>
            <a:xfrm>
              <a:off x="8520179" y="6260352"/>
              <a:ext cx="124966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2C4CC293-7CB6-4D87-A442-5A0EA590A67F}"/>
                </a:ext>
              </a:extLst>
            </p:cNvPr>
            <p:cNvSpPr/>
            <p:nvPr/>
          </p:nvSpPr>
          <p:spPr>
            <a:xfrm>
              <a:off x="8642363" y="6260352"/>
              <a:ext cx="188907" cy="272336"/>
            </a:xfrm>
            <a:prstGeom prst="rect">
              <a:avLst/>
            </a:prstGeom>
            <a:solidFill>
              <a:schemeClr val="accent6">
                <a:alpha val="50196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423B5AB6-4FC9-4009-9478-B5691DB23D00}"/>
                </a:ext>
              </a:extLst>
            </p:cNvPr>
            <p:cNvSpPr/>
            <p:nvPr/>
          </p:nvSpPr>
          <p:spPr>
            <a:xfrm>
              <a:off x="8830186" y="6262403"/>
              <a:ext cx="67039" cy="272336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37279242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40</Words>
  <Application>Microsoft Macintosh PowerPoint</Application>
  <PresentationFormat>Grand écran</PresentationFormat>
  <Paragraphs>1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thilde Duque</dc:creator>
  <cp:lastModifiedBy>DORTET Laurent</cp:lastModifiedBy>
  <cp:revision>12</cp:revision>
  <dcterms:created xsi:type="dcterms:W3CDTF">2025-09-17T11:58:57Z</dcterms:created>
  <dcterms:modified xsi:type="dcterms:W3CDTF">2025-12-24T14:14:10Z</dcterms:modified>
</cp:coreProperties>
</file>